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836863" cy="32940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471AA-B21D-4D39-9C66-39CA08D53C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240984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2760" y="1983240"/>
            <a:ext cx="240984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6CB4AD-D8C3-4C07-B91E-5A45278522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475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2760" y="198324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47560" y="198324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69986-B14C-4519-A1F3-91312A1525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27800" y="95040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42840" y="95040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2760" y="198324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27800" y="198324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42840" y="1983240"/>
            <a:ext cx="77580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77336-C178-4433-B1DA-3C4DB42977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2760" y="950400"/>
            <a:ext cx="2409840" cy="1976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00"/>
              </a:spcBef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786E4-BE65-4EE3-AC0C-DF0E068230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240984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5BA0D-2334-4DAC-AE72-F3DE118220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117576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47560" y="950400"/>
            <a:ext cx="117576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EC030-F397-4371-B528-C722FDC8C8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B35BA-4373-4A12-BF6B-65F25696E4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2760" y="291960"/>
            <a:ext cx="2409840" cy="254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377B4-EBF4-44B3-809D-956E17A3AB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47560" y="950400"/>
            <a:ext cx="117576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2760" y="198324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07DA5-E263-4960-9E2B-B235CBDE65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117576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475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47560" y="198324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3A10C-D756-4059-808C-08610BEF5D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27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47560" y="950400"/>
            <a:ext cx="117576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2760" y="1983240"/>
            <a:ext cx="2409840" cy="9428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/>
          </a:bodyPr>
          <a:p>
            <a:pPr indent="0">
              <a:spcBef>
                <a:spcPts val="300"/>
              </a:spcBef>
              <a:buNone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FA1E8-94C6-4FAC-9469-7E12259981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2760" y="291960"/>
            <a:ext cx="2409840" cy="5493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ctr">
            <a:noAutofit/>
          </a:bodyPr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2760" y="950400"/>
            <a:ext cx="2409840" cy="197676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rmAutofit fontScale="89000"/>
          </a:bodyPr>
          <a:p>
            <a:pPr marL="114120" indent="-114120">
              <a:spcBef>
                <a:spcPts val="300"/>
              </a:spcBef>
              <a:buClr>
                <a:srgbClr val="000000"/>
              </a:buClr>
              <a:buFont typeface="Times"/>
              <a:buChar char="•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1" marL="248400" indent="-94320">
              <a:spcBef>
                <a:spcPts val="300"/>
              </a:spcBef>
              <a:buClr>
                <a:srgbClr val="000000"/>
              </a:buClr>
              <a:buFont typeface="Times"/>
              <a:buChar char="–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2" marL="384120" indent="-77400">
              <a:spcBef>
                <a:spcPts val="300"/>
              </a:spcBef>
              <a:buClr>
                <a:srgbClr val="000000"/>
              </a:buClr>
              <a:buFont typeface="Times"/>
              <a:buChar char="•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3" marL="536760" indent="-75960">
              <a:spcBef>
                <a:spcPts val="300"/>
              </a:spcBef>
              <a:buClr>
                <a:srgbClr val="000000"/>
              </a:buClr>
              <a:buFont typeface="Times"/>
              <a:buChar char="–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4" marL="690480" indent="-77400">
              <a:spcBef>
                <a:spcPts val="300"/>
              </a:spcBef>
              <a:buClr>
                <a:srgbClr val="000000"/>
              </a:buClr>
              <a:buFont typeface="Times"/>
              <a:buChar char="»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5" marL="690480" indent="-77400">
              <a:spcBef>
                <a:spcPts val="300"/>
              </a:spcBef>
              <a:buClr>
                <a:srgbClr val="000000"/>
              </a:buClr>
              <a:buFont typeface="Times"/>
              <a:buChar char="»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lvl="6" marL="690480" indent="-77400">
              <a:spcBef>
                <a:spcPts val="300"/>
              </a:spcBef>
              <a:buClr>
                <a:srgbClr val="000000"/>
              </a:buClr>
              <a:buFont typeface="Times"/>
              <a:buChar char="»"/>
              <a:tabLst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2760" y="2999880"/>
            <a:ext cx="590400" cy="2192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Autofit/>
          </a:bodyPr>
          <a:lstStyle>
            <a:lvl1pPr indent="0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  <a:defRPr b="0" lang="en-US" sz="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68400" y="2999880"/>
            <a:ext cx="898560" cy="2192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Autofit/>
          </a:bodyPr>
          <a:lstStyle>
            <a:lvl1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  <a:defRPr b="0" lang="en-US" sz="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031480" y="2999880"/>
            <a:ext cx="590760" cy="219240"/>
          </a:xfrm>
          <a:prstGeom prst="rect">
            <a:avLst/>
          </a:prstGeom>
          <a:noFill/>
          <a:ln w="0">
            <a:noFill/>
          </a:ln>
        </p:spPr>
        <p:txBody>
          <a:bodyPr lIns="34560" rIns="34560" tIns="17280" bIns="17280" anchor="t">
            <a:noAutofit/>
          </a:bodyPr>
          <a:lstStyle>
            <a:lvl1pPr indent="0" algn="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  <a:defRPr b="0" lang="en-US" sz="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344520"/>
                <a:tab algn="l" pos="689040"/>
                <a:tab algn="l" pos="1033560"/>
                <a:tab algn="l" pos="1378080"/>
                <a:tab algn="l" pos="1722600"/>
                <a:tab algn="l" pos="2066760"/>
                <a:tab algn="l" pos="2411280"/>
                <a:tab algn="l" pos="2755800"/>
                <a:tab algn="l" pos="3100320"/>
                <a:tab algn="l" pos="3444840"/>
                <a:tab algn="l" pos="3789360"/>
                <a:tab algn="l" pos="4133880"/>
                <a:tab algn="l" pos="4478400"/>
                <a:tab algn="l" pos="4822920"/>
                <a:tab algn="l" pos="5167440"/>
                <a:tab algn="l" pos="5511960"/>
                <a:tab algn="l" pos="5856120"/>
                <a:tab algn="l" pos="6200640"/>
                <a:tab algn="l" pos="6545160"/>
                <a:tab algn="l" pos="6889680"/>
              </a:tabLst>
            </a:pPr>
            <a:fld id="{6DFD2DCE-EEC5-4EAF-BC41-523A5D4115FA}" type="slidenum"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3960" y="1690560"/>
            <a:ext cx="2624040" cy="1619280"/>
            <a:chOff x="93960" y="1690560"/>
            <a:chExt cx="2624040" cy="1619280"/>
          </a:xfrm>
        </p:grpSpPr>
        <p:sp>
          <p:nvSpPr>
            <p:cNvPr id="42" name=""/>
            <p:cNvSpPr/>
            <p:nvPr/>
          </p:nvSpPr>
          <p:spPr>
            <a:xfrm>
              <a:off x="2297880" y="1690560"/>
              <a:ext cx="420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% </a:t>
              </a:r>
              <a:br>
                <a:rPr sz="900"/>
              </a:b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input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02960" y="2195280"/>
              <a:ext cx="622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Ubiquitin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12400" y="268416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UMO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93960" y="2941560"/>
              <a:ext cx="646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Wild-type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UBL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1"/>
            <a:srcRect l="279" t="0" r="0" b="0"/>
            <a:stretch/>
          </p:blipFill>
          <p:spPr>
            <a:xfrm>
              <a:off x="796680" y="2166840"/>
              <a:ext cx="1828800" cy="34596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7" name="" descr=""/>
            <p:cNvPicPr/>
            <p:nvPr/>
          </p:nvPicPr>
          <p:blipFill>
            <a:blip r:embed="rId2"/>
            <a:stretch/>
          </p:blipFill>
          <p:spPr>
            <a:xfrm>
              <a:off x="795240" y="2552400"/>
              <a:ext cx="1828800" cy="7081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48" name=""/>
            <p:cNvSpPr/>
            <p:nvPr/>
          </p:nvSpPr>
          <p:spPr>
            <a:xfrm flipH="1" rot="5400000">
              <a:off x="677520" y="2266200"/>
              <a:ext cx="91800" cy="92160"/>
            </a:xfrm>
            <a:prstGeom prst="triangle">
              <a:avLst>
                <a:gd name="adj" fmla="val 50000"/>
              </a:avLst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840" bIns="-15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 flipH="1" rot="5400000">
              <a:off x="668160" y="2752560"/>
              <a:ext cx="92160" cy="92160"/>
            </a:xfrm>
            <a:prstGeom prst="triangle">
              <a:avLst>
                <a:gd name="adj" fmla="val 50000"/>
              </a:avLst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840" bIns="-15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 flipH="1" rot="5400000">
              <a:off x="677520" y="3035160"/>
              <a:ext cx="92160" cy="92160"/>
            </a:xfrm>
            <a:prstGeom prst="triangle">
              <a:avLst>
                <a:gd name="adj" fmla="val 50000"/>
              </a:avLst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840" bIns="-15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511360" y="199836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 flipH="1">
              <a:off x="846000" y="1884240"/>
              <a:ext cx="1371600" cy="22860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720" bIns="277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45920" y="181908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raction number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4" name=""/>
          <p:cNvGrpSpPr/>
          <p:nvPr/>
        </p:nvGrpSpPr>
        <p:grpSpPr>
          <a:xfrm>
            <a:off x="10080" y="-31680"/>
            <a:ext cx="2882520" cy="1661400"/>
            <a:chOff x="10080" y="-31680"/>
            <a:chExt cx="2882520" cy="1661400"/>
          </a:xfrm>
        </p:grpSpPr>
        <p:sp>
          <p:nvSpPr>
            <p:cNvPr id="55" name=""/>
            <p:cNvSpPr/>
            <p:nvPr/>
          </p:nvSpPr>
          <p:spPr>
            <a:xfrm>
              <a:off x="20520" y="1398600"/>
              <a:ext cx="622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Ubiquitin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3"/>
            <a:stretch/>
          </p:blipFill>
          <p:spPr>
            <a:xfrm>
              <a:off x="693720" y="1360440"/>
              <a:ext cx="2101680" cy="24156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57" name=""/>
            <p:cNvSpPr/>
            <p:nvPr/>
          </p:nvSpPr>
          <p:spPr>
            <a:xfrm>
              <a:off x="12960" y="1182600"/>
              <a:ext cx="2879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raction no.              38    40    42    44     46   48    50   52 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8" name=""/>
            <p:cNvGrpSpPr/>
            <p:nvPr/>
          </p:nvGrpSpPr>
          <p:grpSpPr>
            <a:xfrm>
              <a:off x="10080" y="-31680"/>
              <a:ext cx="2821680" cy="1141560"/>
              <a:chOff x="10080" y="-31680"/>
              <a:chExt cx="2821680" cy="1141560"/>
            </a:xfrm>
          </p:grpSpPr>
          <p:sp>
            <p:nvSpPr>
              <p:cNvPr id="59" name=""/>
              <p:cNvSpPr/>
              <p:nvPr/>
            </p:nvSpPr>
            <p:spPr>
              <a:xfrm>
                <a:off x="30240" y="674640"/>
                <a:ext cx="676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Wild-type 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UBL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29960" y="509760"/>
                <a:ext cx="511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SUMO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0080" y="255600"/>
                <a:ext cx="2821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Fraction no.              10    12    14   16   18   20    22    24 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62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690480" y="434880"/>
                <a:ext cx="2102040" cy="675000"/>
              </a:xfrm>
              <a:prstGeom prst="rect">
                <a:avLst/>
              </a:prstGeom>
              <a:ln w="3240">
                <a:solidFill>
                  <a:srgbClr val="000000"/>
                </a:solidFill>
                <a:miter/>
              </a:ln>
            </p:spPr>
          </p:pic>
          <p:sp>
            <p:nvSpPr>
              <p:cNvPr id="63" name=""/>
              <p:cNvSpPr/>
              <p:nvPr/>
            </p:nvSpPr>
            <p:spPr>
              <a:xfrm>
                <a:off x="548640" y="-31680"/>
                <a:ext cx="4201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0% 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input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770040" y="27000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sm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H="1" rot="5400000">
                <a:off x="569880" y="570960"/>
                <a:ext cx="91800" cy="92160"/>
              </a:xfrm>
              <a:prstGeom prst="triangle">
                <a:avLst>
                  <a:gd name="adj" fmla="val 50000"/>
                </a:avLst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5840" bIns="-15840" anchor="t" anchorCtr="1" vert="eaVer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H="1" rot="5400000">
                <a:off x="566640" y="836640"/>
                <a:ext cx="92160" cy="92160"/>
              </a:xfrm>
              <a:prstGeom prst="triangle">
                <a:avLst>
                  <a:gd name="adj" fmla="val 50000"/>
                </a:avLst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5840" bIns="-15840" anchor="t" anchorCtr="1" vert="eaVer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67" name=""/>
            <p:cNvSpPr/>
            <p:nvPr/>
          </p:nvSpPr>
          <p:spPr>
            <a:xfrm flipH="1" rot="5400000">
              <a:off x="566640" y="1471680"/>
              <a:ext cx="92160" cy="92160"/>
            </a:xfrm>
            <a:prstGeom prst="triangle">
              <a:avLst>
                <a:gd name="adj" fmla="val 50000"/>
              </a:avLst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840" bIns="-15840" anchor="t" anchorCtr="1" vert="eaVer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-68400" y="-44280"/>
            <a:ext cx="32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-66960" y="1652760"/>
            <a:ext cx="32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5T18:44:41Z</dcterms:created>
  <dc:creator>Amanda Chan</dc:creator>
  <dc:description/>
  <dc:language>en-US</dc:language>
  <cp:lastModifiedBy>Peter Howley</cp:lastModifiedBy>
  <dcterms:modified xsi:type="dcterms:W3CDTF">2008-02-20T17:22:01Z</dcterms:modified>
  <cp:revision>2</cp:revision>
  <dc:subject/>
  <dc:title>PowerPoint Presentation</dc:title>
</cp:coreProperties>
</file>